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3" d="100"/>
          <a:sy n="83" d="100"/>
        </p:scale>
        <p:origin x="-105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361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138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406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1728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928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4443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081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1042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2997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020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9542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14C91-A375-40F7-B834-35EFBF51A89C}" type="datetimeFigureOut">
              <a:rPr lang="en-GB" smtClean="0"/>
              <a:t>0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95724-E838-441A-A9BE-E4A1097640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274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5546666"/>
              </p:ext>
            </p:extLst>
          </p:nvPr>
        </p:nvGraphicFramePr>
        <p:xfrm>
          <a:off x="1421650" y="1095650"/>
          <a:ext cx="6673253" cy="29703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CS ChemDraw Drawing" r:id="rId3" imgW="7194451" imgH="3195450" progId="ChemDraw.Document.6.0">
                  <p:embed/>
                </p:oleObj>
              </mc:Choice>
              <mc:Fallback>
                <p:oleObj name="CS ChemDraw Drawing" r:id="rId3" imgW="7194451" imgH="3195450" progId="ChemDraw.Document.6.0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21650" y="1095650"/>
                        <a:ext cx="6673253" cy="297033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7"/>
          <p:cNvSpPr>
            <a:spLocks noChangeArrowheads="1"/>
          </p:cNvSpPr>
          <p:nvPr/>
        </p:nvSpPr>
        <p:spPr bwMode="auto">
          <a:xfrm rot="10800000" flipV="1">
            <a:off x="1241628" y="4613935"/>
            <a:ext cx="6705746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Figure S2: The synthesis of Oxaborole-3 and Oxaborole-Resin.  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Reagents and conditions; a) DIPEA, 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TsCl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DMAP, CH</a:t>
            </a:r>
            <a:r>
              <a:rPr kumimoji="0" lang="en-GB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l</a:t>
            </a:r>
            <a:r>
              <a:rPr kumimoji="0" lang="en-GB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room temp., 16 h, 28%; b) methyl 3-hydroxybenzoate, K</a:t>
            </a:r>
            <a:r>
              <a:rPr kumimoji="0" lang="en-GB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O</a:t>
            </a:r>
            <a:r>
              <a:rPr kumimoji="0" lang="en-GB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3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MeCN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82ºC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16 h, 96%; c) NaOH, THF/water, 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70ºC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2 h, 84%; d) 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i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DIPEA, TBTU, THF, room temp., 20 h. ii, DIPEA, </a:t>
            </a: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I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THF/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MeCN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room temp., 16 h, 52%; e) TFA, CH</a:t>
            </a:r>
            <a:r>
              <a:rPr kumimoji="0" lang="en-GB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Cl</a:t>
            </a:r>
            <a:r>
              <a:rPr kumimoji="0" lang="en-GB" altLang="en-US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0ºC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2 h, 96%; f) 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i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) HCl, </a:t>
            </a:r>
            <a:r>
              <a:rPr kumimoji="0" lang="en-GB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dioxane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/THF, 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5ºC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72 h, ii) DIPEA, </a:t>
            </a:r>
            <a:r>
              <a:rPr kumimoji="0" lang="en-GB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II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THF, 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5ºC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48 h, 48%; g) DIPEA, NHS-functionalised beads DMSO, </a:t>
            </a:r>
            <a:r>
              <a:rPr lang="en-GB" altLang="en-US" sz="1200" dirty="0"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25ºC</a:t>
            </a:r>
            <a:r>
              <a: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Mincho" pitchFamily="49" charset="-128"/>
                <a:cs typeface="Times New Roman" pitchFamily="18" charset="0"/>
              </a:rPr>
              <a:t>, 24 h.</a:t>
            </a: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5693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4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CS ChemDraw Drawing</vt:lpstr>
      <vt:lpstr>PowerPoint Presentation</vt:lpstr>
    </vt:vector>
  </TitlesOfParts>
  <Company>University of Dunde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Fairlamb</dc:creator>
  <cp:lastModifiedBy>Alan Fairlamb</cp:lastModifiedBy>
  <cp:revision>5</cp:revision>
  <dcterms:created xsi:type="dcterms:W3CDTF">2015-08-14T13:23:41Z</dcterms:created>
  <dcterms:modified xsi:type="dcterms:W3CDTF">2015-11-02T09:30:57Z</dcterms:modified>
</cp:coreProperties>
</file>